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795E9F-234D-408C-B3B5-D3082EAE36F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3BCC9A-EF1B-4375-9F80-C51D22E8A6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0E56B1-2825-4FBA-A579-18FD34E2652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7A4488-2738-4C34-B732-2ED12D6A935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6F47DC-0D6C-4023-A529-CF4938B541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21ED3C-D0B0-43A9-80EC-4784588275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443958-CCAD-427E-8F2B-B50EAB7BBC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460546-E4AC-4E35-8852-0AC6192E7D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CBAE6E-02FE-4236-B619-6326104E1D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2F0F5A-7671-4FC5-AEDE-6CFB9AA0DD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50093E-EE89-47A6-9BE1-19116CE587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113786-F21D-4F54-9274-52CA4C56DD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E8CA958-03E6-496D-B0F6-D529927D6938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4227480" y="565200"/>
          <a:ext cx="3821040" cy="5151240"/>
        </p:xfrm>
        <a:graphic>
          <a:graphicData uri="http://schemas.openxmlformats.org/drawingml/2006/table">
            <a:tbl>
              <a:tblPr/>
              <a:tblGrid>
                <a:gridCol w="658800"/>
                <a:gridCol w="598680"/>
                <a:gridCol w="880920"/>
                <a:gridCol w="880920"/>
                <a:gridCol w="801720"/>
              </a:tblGrid>
              <a:tr h="29376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ne I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ne nam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-inflorescence-inflorescenc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florescence-flowerin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florescence-inflorescenc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736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690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CR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10808"/>
                    </a:solidFill>
                  </a:tcPr>
                </a:tc>
              </a:tr>
              <a:tr h="11916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694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NAC02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80909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05f86"/>
                    </a:solidFill>
                  </a:tcPr>
                </a:tc>
              </a:tr>
              <a:tr h="11880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139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nkyri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30808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772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242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PI4Kc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7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9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11880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44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BX2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c0808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772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218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BX3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f0808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916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54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LH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a3c53"/>
                    </a:solidFill>
                  </a:tcPr>
                </a:tc>
              </a:tr>
              <a:tr h="11880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423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ZIP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0707"/>
                    </a:solidFill>
                  </a:tcPr>
                </a:tc>
              </a:tr>
              <a:tr h="11772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158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OL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d415a"/>
                    </a:solidFill>
                  </a:tcPr>
                </a:tc>
              </a:tr>
              <a:tr h="11880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231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RK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f445e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.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11916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232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RK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75070"/>
                    </a:solidFill>
                  </a:tcPr>
                </a:tc>
              </a:tr>
              <a:tr h="11736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251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YP71B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93a4f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916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223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YP79B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54e6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916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254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GR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a0808"/>
                    </a:solidFill>
                  </a:tcPr>
                </a:tc>
              </a:tr>
              <a:tr h="11736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299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LF4-L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.0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11916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26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LF4-L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53446"/>
                    </a:solidFill>
                  </a:tcPr>
                </a:tc>
              </a:tr>
              <a:tr h="11916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055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AD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90909"/>
                    </a:solidFill>
                  </a:tcPr>
                </a:tc>
              </a:tr>
              <a:tr h="11736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091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BH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d0808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90909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916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540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LN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d0808"/>
                    </a:solidFill>
                  </a:tcPr>
                </a:tc>
              </a:tr>
              <a:tr h="11880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313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LP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e0707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772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149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R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04560"/>
                    </a:solidFill>
                  </a:tcPr>
                </a:tc>
              </a:tr>
              <a:tr h="11880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654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9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0101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772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155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3OX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e0606"/>
                    </a:solidFill>
                  </a:tcPr>
                </a:tc>
              </a:tr>
              <a:tr h="11880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227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I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10707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916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630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ID1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c0909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772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273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ID1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f435d"/>
                    </a:solidFill>
                  </a:tcPr>
                </a:tc>
              </a:tr>
              <a:tr h="11880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216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RP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50404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916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222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C08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e435c"/>
                    </a:solidFill>
                  </a:tcPr>
                </a:tc>
              </a:tr>
              <a:tr h="11736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061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ORA5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f0707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b577b"/>
                    </a:solidFill>
                  </a:tcPr>
                </a:tc>
              </a:tr>
              <a:tr h="11916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181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HY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63548"/>
                    </a:solidFill>
                  </a:tcPr>
                </a:tc>
              </a:tr>
              <a:tr h="11916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398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70808"/>
                    </a:solidFill>
                  </a:tcPr>
                </a:tc>
              </a:tr>
              <a:tr h="11736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202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M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05f86"/>
                    </a:solidFill>
                  </a:tcPr>
                </a:tc>
              </a:tr>
              <a:tr h="11916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132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AV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e425c"/>
                    </a:solidFill>
                  </a:tcPr>
                </a:tc>
              </a:tr>
              <a:tr h="11916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140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OXY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5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11736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255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EM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a3c53"/>
                    </a:solidFill>
                  </a:tcPr>
                </a:tc>
              </a:tr>
              <a:tr h="11916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435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I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70606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736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81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RM112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90909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916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301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GT87A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e0505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90808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20909"/>
                    </a:solidFill>
                  </a:tcPr>
                </a:tc>
              </a:tr>
              <a:tr h="11880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093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093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90808"/>
                    </a:solidFill>
                  </a:tcPr>
                </a:tc>
              </a:tr>
              <a:tr h="11772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809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809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b3d54"/>
                    </a:solidFill>
                  </a:tcPr>
                </a:tc>
              </a:tr>
              <a:tr h="118800"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61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61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0808"/>
                    </a:solidFill>
                  </a:tcPr>
                </a:tc>
              </a:tr>
            </a:tbl>
          </a:graphicData>
        </a:graphic>
      </p:graphicFrame>
      <p:grpSp>
        <p:nvGrpSpPr>
          <p:cNvPr id="42" name="Gruppieren 4"/>
          <p:cNvGrpSpPr/>
          <p:nvPr/>
        </p:nvGrpSpPr>
        <p:grpSpPr>
          <a:xfrm>
            <a:off x="4254480" y="5781600"/>
            <a:ext cx="2238480" cy="401400"/>
            <a:chOff x="4254480" y="5781600"/>
            <a:chExt cx="2238480" cy="401400"/>
          </a:xfrm>
        </p:grpSpPr>
        <p:grpSp>
          <p:nvGrpSpPr>
            <p:cNvPr id="43" name="Gruppieren 4"/>
            <p:cNvGrpSpPr/>
            <p:nvPr/>
          </p:nvGrpSpPr>
          <p:grpSpPr>
            <a:xfrm>
              <a:off x="4332600" y="5781600"/>
              <a:ext cx="2160360" cy="215640"/>
              <a:chOff x="4332600" y="5781600"/>
              <a:chExt cx="2160360" cy="215640"/>
            </a:xfrm>
          </p:grpSpPr>
          <p:pic>
            <p:nvPicPr>
              <p:cNvPr id="44" name="Grafik 1" descr=""/>
              <p:cNvPicPr/>
              <p:nvPr/>
            </p:nvPicPr>
            <p:blipFill>
              <a:blip r:embed="rId1"/>
              <a:stretch/>
            </p:blipFill>
            <p:spPr>
              <a:xfrm>
                <a:off x="4332600" y="5832360"/>
                <a:ext cx="1134360" cy="152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5" name="Textfeld 2"/>
              <p:cNvSpPr/>
              <p:nvPr/>
            </p:nvSpPr>
            <p:spPr>
              <a:xfrm>
                <a:off x="5436360" y="5781600"/>
                <a:ext cx="10566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og</a:t>
                </a: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fold change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46" name="Textfeld 2"/>
            <p:cNvSpPr/>
            <p:nvPr/>
          </p:nvSpPr>
          <p:spPr>
            <a:xfrm>
              <a:off x="5288040" y="5906520"/>
              <a:ext cx="24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feld 7"/>
            <p:cNvSpPr/>
            <p:nvPr/>
          </p:nvSpPr>
          <p:spPr>
            <a:xfrm>
              <a:off x="4254480" y="5894280"/>
              <a:ext cx="24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8" name="Textfeld 2"/>
          <p:cNvSpPr/>
          <p:nvPr/>
        </p:nvSpPr>
        <p:spPr>
          <a:xfrm>
            <a:off x="255600" y="155520"/>
            <a:ext cx="890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  <a:ea typeface="Arial"/>
              </a:rPr>
              <a:t>Fig. S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3-04T12:57:43Z</dcterms:created>
  <dc:creator>Hossein</dc:creator>
  <dc:description/>
  <dc:language>en-US</dc:language>
  <cp:lastModifiedBy>Hossein</cp:lastModifiedBy>
  <dcterms:modified xsi:type="dcterms:W3CDTF">2020-03-20T15:33:04Z</dcterms:modified>
  <cp:revision>11</cp:revision>
  <dc:subject/>
  <dc:title>PowerPoint-Präsentation</dc:title>
</cp:coreProperties>
</file>